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55"/>
    <p:restoredTop sz="94724"/>
  </p:normalViewPr>
  <p:slideViewPr>
    <p:cSldViewPr snapToGrid="0" snapToObjects="1">
      <p:cViewPr varScale="1">
        <p:scale>
          <a:sx n="103" d="100"/>
          <a:sy n="103" d="100"/>
        </p:scale>
        <p:origin x="2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DEC2AB1-70AB-C443-B54E-5ECFC0EBB5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E9B1849E-2E32-F84D-A639-55623633B3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E69F669-938E-3047-8C04-F11D29BC5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6835F8-9C6B-7F4F-A70D-06B18D1CF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EDC651B-5EBA-3545-82D3-AA33F18BF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1667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177237-CD8F-5443-AA8D-6F84D8E819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0CF06A9-CD6B-384D-8B4D-35225D617D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BEF805E-889E-4B4F-AE9E-C7C828A47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A2C0417-144E-3A4C-80FC-D98BF8291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B16BECA-EBA2-FA45-B537-FB1BEFD78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1378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1C44CDE1-1274-5D40-9717-8ED0ED8237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64D9677-6A8D-D045-AE4D-DB3F22F572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185042-F29C-BC48-AE02-5DF740523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29D676E-CB77-F447-96DE-31EA8A458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E50F4AE-1D8A-A64E-8050-7573C1A01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4756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1736409-1C99-D94E-954E-866B6AEF7A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E06629B-8321-924F-8840-B86AFE0DCA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1E87C73-1010-2F42-8984-F71F547B4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CFC8334-7DB5-5842-A6AD-4C7B26F8F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5BD7D68-F13B-894E-845D-7DA1A977D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5025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88E1180-35C9-AD48-884D-87352F52F5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1448EF7-CA14-854C-931D-A326257C63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2C02947-2D9C-1347-B1E1-760350DB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5076D01-EC96-F54F-8F0E-2273076AD8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48C1263-516C-404C-92FF-046B6C7A4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2831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07A71C-D699-D947-B7D1-CB564321AE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69C165C-9CA2-5642-B54D-0D33DEA234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BA67BFE-F41A-8446-B7BF-5DE085DB54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56AF527-422E-1A4F-9AD0-4E6043E24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8F5DF91-3689-314D-BA32-AD7F49251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6EC4823-3356-894F-998C-BB1CDB28A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1856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B6FB8B-AE41-A040-A2C7-B8F1EA7437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15025CC-15D4-194E-84C2-66A58E3CD8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4F9D588-53CA-3942-96F7-477D97C8D1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1528BDC-B3B0-804C-9B4B-C04353E68E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7E43629-853C-0C4E-B0E4-2C2B78478A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661B0C5B-5637-EC42-8F07-852B932B8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8957272-9BFF-714E-80D3-6C8FEED32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919584B-E1CE-1C46-B281-5CDA808D5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1626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070DBA3-1257-DE4B-BC64-6952E03E2A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F38C9CB-DE0B-9D4E-BE9D-35357F2E3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1CD25A5-F04E-D34C-90F9-9B27A1F31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90E122C-8B36-A24A-B577-C3CD3CA91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6809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9F401E5D-7016-8043-9941-CE98BAF0A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2E4BA36-6938-EC46-997E-78084F8B0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512CA8E-45BD-6749-91E1-901AE71D0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5562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A88A9FD-0B72-7349-8733-E4EEE96ED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30AE7FA-944D-3E44-9736-A315479652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39501A8-784B-664B-8115-1F8521830A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1AB01C1-2226-AA44-989C-4B9EB30F3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162EF7A-7EFD-CE4C-8926-44E0C0743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0D45A3F-5914-834C-B00A-DA943E7E57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5400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65C2C3A-8672-5542-8C03-D89AEF358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EA1C5EC-098D-914C-A169-C58B2E49BA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58C5BFA-C7B4-3A4B-8D65-2A58EBA3C9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F67409D-6EE0-5D40-B3B1-93D5A651A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870C938-E12C-D748-9C39-3E8A849C7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A917A16-E9BD-0744-ADA4-3256138BE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1813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17C31FA-BB1B-A54D-BF6D-EBD092AD13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02A01B6-7963-9A49-B04C-A4A8C6D390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C9D0D9D-826F-744C-80F4-4C74B8942D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31E204D-6E97-8742-B686-CA6A53E3D7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CB227F5-2DA0-F341-9098-B219B472B8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6351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FE90BE3B-BD6C-1440-BCBF-39DB2F129881}"/>
              </a:ext>
            </a:extLst>
          </p:cNvPr>
          <p:cNvSpPr txBox="1"/>
          <p:nvPr/>
        </p:nvSpPr>
        <p:spPr>
          <a:xfrm>
            <a:off x="0" y="15103"/>
            <a:ext cx="12192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: Gpr10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express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mot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/IGF-1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lacti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persecre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kelet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growt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L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Photo of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trac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emur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WT (+/+) and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7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1400">
                <a:latin typeface="Arial" panose="020B0604020202020204" pitchFamily="34" charset="0"/>
                <a:cs typeface="Arial" panose="020B0604020202020204" pitchFamily="34" charset="0"/>
              </a:rPr>
              <a:t>males)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B7FC1BB2-0E3A-C743-825A-1EA2039001B7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3756454" y="2273998"/>
            <a:ext cx="2994077" cy="30198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F018B555-8C2E-D940-8925-E96FE7596450}"/>
              </a:ext>
            </a:extLst>
          </p:cNvPr>
          <p:cNvSpPr txBox="1"/>
          <p:nvPr/>
        </p:nvSpPr>
        <p:spPr>
          <a:xfrm>
            <a:off x="5695711" y="1850903"/>
            <a:ext cx="5613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lang="fr-FR" sz="2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fr-F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2EA4FE97-FD03-A148-9AF9-678DB7A5F3CE}"/>
              </a:ext>
            </a:extLst>
          </p:cNvPr>
          <p:cNvSpPr txBox="1"/>
          <p:nvPr/>
        </p:nvSpPr>
        <p:spPr>
          <a:xfrm>
            <a:off x="4220427" y="1879736"/>
            <a:ext cx="5533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5B375F08-A4B4-014E-A512-2C0A784B0488}"/>
              </a:ext>
            </a:extLst>
          </p:cNvPr>
          <p:cNvSpPr txBox="1"/>
          <p:nvPr/>
        </p:nvSpPr>
        <p:spPr>
          <a:xfrm>
            <a:off x="3756454" y="5316837"/>
            <a:ext cx="29940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 dirty="0" err="1">
                <a:latin typeface="Arial" panose="020B0604020202020204" pitchFamily="34" charset="0"/>
                <a:cs typeface="Arial" panose="020B0604020202020204" pitchFamily="34" charset="0"/>
              </a:rPr>
              <a:t>Femur</a:t>
            </a:r>
            <a:endParaRPr lang="fr-F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9836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5</Words>
  <Application>Microsoft Macintosh PowerPoint</Application>
  <PresentationFormat>Grand écran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4</cp:revision>
  <dcterms:created xsi:type="dcterms:W3CDTF">2020-05-10T10:31:28Z</dcterms:created>
  <dcterms:modified xsi:type="dcterms:W3CDTF">2020-05-25T17:30:38Z</dcterms:modified>
</cp:coreProperties>
</file>